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7"/>
  </p:notesMasterIdLst>
  <p:sldIdLst>
    <p:sldId id="305" r:id="rId2"/>
    <p:sldId id="304" r:id="rId3"/>
    <p:sldId id="306" r:id="rId4"/>
    <p:sldId id="300" r:id="rId5"/>
    <p:sldId id="310" r:id="rId6"/>
    <p:sldId id="311" r:id="rId7"/>
    <p:sldId id="312" r:id="rId8"/>
    <p:sldId id="315" r:id="rId9"/>
    <p:sldId id="317" r:id="rId10"/>
    <p:sldId id="318" r:id="rId11"/>
    <p:sldId id="319" r:id="rId12"/>
    <p:sldId id="354" r:id="rId13"/>
    <p:sldId id="323" r:id="rId14"/>
    <p:sldId id="324" r:id="rId15"/>
    <p:sldId id="325" r:id="rId16"/>
    <p:sldId id="288" r:id="rId17"/>
    <p:sldId id="326" r:id="rId18"/>
    <p:sldId id="327" r:id="rId19"/>
    <p:sldId id="328" r:id="rId20"/>
    <p:sldId id="330" r:id="rId21"/>
    <p:sldId id="331" r:id="rId22"/>
    <p:sldId id="332" r:id="rId23"/>
    <p:sldId id="333" r:id="rId24"/>
    <p:sldId id="334" r:id="rId25"/>
    <p:sldId id="335" r:id="rId26"/>
    <p:sldId id="329" r:id="rId27"/>
    <p:sldId id="336" r:id="rId28"/>
    <p:sldId id="338" r:id="rId29"/>
    <p:sldId id="341" r:id="rId30"/>
    <p:sldId id="343" r:id="rId31"/>
    <p:sldId id="344" r:id="rId32"/>
    <p:sldId id="346" r:id="rId33"/>
    <p:sldId id="349" r:id="rId34"/>
    <p:sldId id="352" r:id="rId35"/>
    <p:sldId id="351" r:id="rId3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53" autoAdjust="0"/>
    <p:restoredTop sz="93886" autoAdjust="0"/>
  </p:normalViewPr>
  <p:slideViewPr>
    <p:cSldViewPr snapToGrid="0">
      <p:cViewPr varScale="1">
        <p:scale>
          <a:sx n="71" d="100"/>
          <a:sy n="71" d="100"/>
        </p:scale>
        <p:origin x="86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notesMaster" Target="notesMasters/notesMaster1.xml"/><Relationship Id="rId40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C6B098-E4F7-42A5-AB6B-C8946BEA18B2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7ECE3B-5DEB-46BA-9663-A444FD86EBD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8808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7ECE3B-5DEB-46BA-9663-A444FD86EBDB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09467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87ECE3B-5DEB-46BA-9663-A444FD86EBDB}" type="slidenum">
              <a:rPr lang="zh-CN" altLang="en-US" smtClean="0"/>
              <a:t>1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42967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0143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741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8943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0323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381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75544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259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28514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1846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80479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9218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A7F55-068E-4A76-A66D-AA9376AF2B30}" type="datetimeFigureOut">
              <a:rPr lang="zh-CN" altLang="en-US" smtClean="0"/>
              <a:t>2018/2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986B7D-0CDC-4B5E-8756-C24E5BDC52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3788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9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2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5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8.pn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png"/><Relationship Id="rId5" Type="http://schemas.openxmlformats.org/officeDocument/2006/relationships/image" Target="../media/image53.png"/><Relationship Id="rId4" Type="http://schemas.openxmlformats.org/officeDocument/2006/relationships/image" Target="../media/image5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emf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1.png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emf"/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6.png"/><Relationship Id="rId5" Type="http://schemas.openxmlformats.org/officeDocument/2006/relationships/image" Target="../media/image65.png"/><Relationship Id="rId4" Type="http://schemas.openxmlformats.org/officeDocument/2006/relationships/image" Target="../media/image64.png"/><Relationship Id="rId9" Type="http://schemas.openxmlformats.org/officeDocument/2006/relationships/image" Target="../media/image69.pn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emf"/><Relationship Id="rId3" Type="http://schemas.openxmlformats.org/officeDocument/2006/relationships/image" Target="../media/image71.png"/><Relationship Id="rId7" Type="http://schemas.openxmlformats.org/officeDocument/2006/relationships/image" Target="../media/image75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4.png"/><Relationship Id="rId5" Type="http://schemas.openxmlformats.org/officeDocument/2006/relationships/image" Target="../media/image73.png"/><Relationship Id="rId4" Type="http://schemas.openxmlformats.org/officeDocument/2006/relationships/image" Target="../media/image72.png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emf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emf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0.pn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2.emf"/><Relationship Id="rId2" Type="http://schemas.openxmlformats.org/officeDocument/2006/relationships/image" Target="../media/image81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png"/><Relationship Id="rId2" Type="http://schemas.openxmlformats.org/officeDocument/2006/relationships/image" Target="../media/image8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5.png"/></Relationships>
</file>

<file path=ppt/slides/_rels/slide29.xml.rels><?xml version="1.0" encoding="UTF-8" standalone="yes"?>
<Relationships xmlns="http://schemas.openxmlformats.org/package/2006/relationships"><Relationship Id="rId8" Type="http://schemas.openxmlformats.org/officeDocument/2006/relationships/image" Target="../media/image92.png"/><Relationship Id="rId3" Type="http://schemas.openxmlformats.org/officeDocument/2006/relationships/image" Target="../media/image87.png"/><Relationship Id="rId7" Type="http://schemas.openxmlformats.org/officeDocument/2006/relationships/image" Target="../media/image91.png"/><Relationship Id="rId2" Type="http://schemas.openxmlformats.org/officeDocument/2006/relationships/image" Target="../media/image8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0.png"/><Relationship Id="rId11" Type="http://schemas.openxmlformats.org/officeDocument/2006/relationships/image" Target="../media/image95.png"/><Relationship Id="rId5" Type="http://schemas.openxmlformats.org/officeDocument/2006/relationships/image" Target="../media/image89.png"/><Relationship Id="rId10" Type="http://schemas.openxmlformats.org/officeDocument/2006/relationships/image" Target="../media/image94.png"/><Relationship Id="rId4" Type="http://schemas.openxmlformats.org/officeDocument/2006/relationships/image" Target="../media/image88.png"/><Relationship Id="rId9" Type="http://schemas.openxmlformats.org/officeDocument/2006/relationships/image" Target="../media/image9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emf"/><Relationship Id="rId2" Type="http://schemas.openxmlformats.org/officeDocument/2006/relationships/image" Target="../media/image9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8.png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9.emf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png"/><Relationship Id="rId2" Type="http://schemas.openxmlformats.org/officeDocument/2006/relationships/image" Target="../media/image100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2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emf"/><Relationship Id="rId2" Type="http://schemas.openxmlformats.org/officeDocument/2006/relationships/image" Target="../media/image10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5.pn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7.png"/><Relationship Id="rId2" Type="http://schemas.openxmlformats.org/officeDocument/2006/relationships/image" Target="../media/image10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8.emf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emf"/><Relationship Id="rId2" Type="http://schemas.openxmlformats.org/officeDocument/2006/relationships/image" Target="../media/image10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/>
          <a:srcRect l="8199" t="6075" r="3389" b="20283"/>
          <a:stretch/>
        </p:blipFill>
        <p:spPr>
          <a:xfrm>
            <a:off x="9332308" y="2449507"/>
            <a:ext cx="2174875" cy="500831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8985953" y="3079300"/>
            <a:ext cx="26853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ps_ACP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468351" y="1512469"/>
            <a:ext cx="8385717" cy="3048380"/>
            <a:chOff x="596240" y="811770"/>
            <a:chExt cx="9651794" cy="3644800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96240" y="811770"/>
              <a:ext cx="6952576" cy="3644800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4"/>
            <a:srcRect l="29520" r="46441" b="76967"/>
            <a:stretch/>
          </p:blipFill>
          <p:spPr>
            <a:xfrm>
              <a:off x="7548816" y="912397"/>
              <a:ext cx="2699218" cy="3523184"/>
            </a:xfrm>
            <a:prstGeom prst="rect">
              <a:avLst/>
            </a:prstGeom>
          </p:spPr>
        </p:pic>
      </p:grpSp>
      <p:sp>
        <p:nvSpPr>
          <p:cNvPr id="12" name="右大括号 11"/>
          <p:cNvSpPr/>
          <p:nvPr/>
        </p:nvSpPr>
        <p:spPr>
          <a:xfrm>
            <a:off x="8877299" y="1863213"/>
            <a:ext cx="285750" cy="169402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98431" y="100361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5227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/>
          <a:srcRect l="8147" t="20318" r="2992" b="20588"/>
          <a:stretch/>
        </p:blipFill>
        <p:spPr>
          <a:xfrm>
            <a:off x="7277100" y="6299201"/>
            <a:ext cx="1846560" cy="339498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40131" y="0"/>
            <a:ext cx="6303869" cy="6054732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438401" y="6258525"/>
            <a:ext cx="46355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 &amp; other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ects_CCAP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8432" y="90773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7125938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4000" y="0"/>
            <a:ext cx="4459591" cy="6858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4"/>
          <a:srcRect l="44057" r="10942" b="12287"/>
          <a:stretch/>
        </p:blipFill>
        <p:spPr>
          <a:xfrm>
            <a:off x="5983591" y="46300"/>
            <a:ext cx="2172023" cy="68117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32962" y="542805"/>
            <a:ext cx="2641912" cy="730411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37135" y="4385600"/>
            <a:ext cx="2641912" cy="730411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8526638" y="1486650"/>
            <a:ext cx="30684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CCHa-2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8604697" y="5300368"/>
            <a:ext cx="30684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CCHa-1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98432" y="90773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5034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31907" r="26101" b="55356"/>
          <a:stretch/>
        </p:blipFill>
        <p:spPr>
          <a:xfrm>
            <a:off x="5047147" y="855312"/>
            <a:ext cx="3494686" cy="506138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04419"/>
            <a:ext cx="5060855" cy="5078823"/>
          </a:xfrm>
          <a:prstGeom prst="rect">
            <a:avLst/>
          </a:prstGeom>
        </p:spPr>
      </p:pic>
      <p:sp>
        <p:nvSpPr>
          <p:cNvPr id="7" name="右大括号 6"/>
          <p:cNvSpPr/>
          <p:nvPr/>
        </p:nvSpPr>
        <p:spPr>
          <a:xfrm>
            <a:off x="8587012" y="924742"/>
            <a:ext cx="237673" cy="283445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4"/>
          <a:srcRect l="7647" t="21428" r="2941"/>
          <a:stretch/>
        </p:blipFill>
        <p:spPr>
          <a:xfrm>
            <a:off x="8984342" y="2061030"/>
            <a:ext cx="2859313" cy="555764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9941981" y="2742323"/>
            <a:ext cx="9268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NM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98432" y="90773"/>
            <a:ext cx="4539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7382183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3128" y="680224"/>
            <a:ext cx="4515068" cy="5842001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/>
          <a:srcRect l="30429" b="41690"/>
          <a:stretch/>
        </p:blipFill>
        <p:spPr>
          <a:xfrm>
            <a:off x="5736041" y="680224"/>
            <a:ext cx="5116617" cy="5842000"/>
          </a:xfrm>
          <a:prstGeom prst="rect">
            <a:avLst/>
          </a:prstGeom>
        </p:spPr>
      </p:pic>
      <p:pic>
        <p:nvPicPr>
          <p:cNvPr id="1026" name="Picture 2" descr="http://weblogo.berkeley.edu/cache/fileCplBL4.pn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21" t="17093" r="3295"/>
          <a:stretch/>
        </p:blipFill>
        <p:spPr bwMode="auto">
          <a:xfrm>
            <a:off x="5887845" y="245327"/>
            <a:ext cx="4583150" cy="414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文本框 5"/>
          <p:cNvSpPr txBox="1"/>
          <p:nvPr/>
        </p:nvSpPr>
        <p:spPr>
          <a:xfrm>
            <a:off x="2712274" y="234702"/>
            <a:ext cx="27975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wasps_DH31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98432" y="90773"/>
            <a:ext cx="5245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i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762518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60088"/>
            <a:ext cx="4410477" cy="4884233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/>
          <a:srcRect l="18082" r="13381" b="52674"/>
          <a:stretch/>
        </p:blipFill>
        <p:spPr>
          <a:xfrm>
            <a:off x="4374736" y="1332108"/>
            <a:ext cx="7813545" cy="4750536"/>
          </a:xfrm>
          <a:prstGeom prst="rect">
            <a:avLst/>
          </a:prstGeom>
        </p:spPr>
      </p:pic>
      <p:pic>
        <p:nvPicPr>
          <p:cNvPr id="2050" name="Picture 2" descr="filehCkWb3.png (680×188)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6" t="23405" r="3157"/>
          <a:stretch/>
        </p:blipFill>
        <p:spPr bwMode="auto">
          <a:xfrm>
            <a:off x="5698274" y="769435"/>
            <a:ext cx="6188925" cy="5798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文本框 9"/>
          <p:cNvSpPr txBox="1"/>
          <p:nvPr/>
        </p:nvSpPr>
        <p:spPr>
          <a:xfrm>
            <a:off x="2500400" y="825719"/>
            <a:ext cx="279756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wasps_DH43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98432" y="90773"/>
            <a:ext cx="511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iv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204457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20141"/>
            <a:ext cx="3132345" cy="310896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/>
          <a:srcRect l="16379" r="2905" b="66762"/>
          <a:stretch/>
        </p:blipFill>
        <p:spPr>
          <a:xfrm>
            <a:off x="3166108" y="1169941"/>
            <a:ext cx="8980172" cy="3047728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4"/>
          <a:srcRect l="13731" t="27893" r="4835"/>
          <a:stretch/>
        </p:blipFill>
        <p:spPr>
          <a:xfrm>
            <a:off x="4995746" y="724828"/>
            <a:ext cx="6802243" cy="454877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875932" y="725358"/>
            <a:ext cx="25266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EH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98432" y="90773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v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09962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812801"/>
            <a:ext cx="5335114" cy="5111827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/>
          <a:srcRect l="28313" b="57756"/>
          <a:stretch/>
        </p:blipFill>
        <p:spPr>
          <a:xfrm>
            <a:off x="5779614" y="872025"/>
            <a:ext cx="6220250" cy="4993376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4"/>
          <a:srcRect l="7451" t="28404" r="2940"/>
          <a:stretch/>
        </p:blipFill>
        <p:spPr>
          <a:xfrm>
            <a:off x="7734300" y="254000"/>
            <a:ext cx="3784600" cy="561974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438032" y="369758"/>
            <a:ext cx="311014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Eleven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8432" y="90773"/>
            <a:ext cx="511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v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689308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4244621" y="1800578"/>
            <a:ext cx="7947379" cy="300082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zh-CN" sz="1050" dirty="0">
                <a:latin typeface="Courier"/>
              </a:rPr>
              <a:t>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SSSGGNLGSSF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NGD----------DLGLS--------QPHT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41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S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GGNMGSSF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NSD----------DLGVS--------QPHT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40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S</a:t>
            </a:r>
            <a:r>
              <a:rPr lang="en-US" altLang="zh-CN" sz="1050" dirty="0">
                <a:latin typeface="Courier"/>
              </a:rPr>
              <a:t>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GSN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GGD----------LDAVS--------QPHT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II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39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S</a:t>
            </a:r>
            <a:r>
              <a:rPr lang="en-US" altLang="zh-CN" sz="1050" dirty="0">
                <a:latin typeface="Courier"/>
              </a:rPr>
              <a:t>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L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DRDAA--------LGSVS--------QPHT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TV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39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S</a:t>
            </a:r>
            <a:r>
              <a:rPr lang="en-US" altLang="zh-CN" sz="1050" dirty="0">
                <a:latin typeface="Courier"/>
              </a:rPr>
              <a:t>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DIAVS--------QPHT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II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33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N</a:t>
            </a:r>
            <a:r>
              <a:rPr lang="en-US" altLang="zh-CN" sz="1050" dirty="0">
                <a:latin typeface="Courier"/>
              </a:rPr>
              <a:t>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TPA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GSSN--------GGAIS--------PPHT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40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Q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NHMANNGENIEYSLNTVNDLDA-SSRIPRG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53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Q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NHMANNGENIEYSLNTVNDLDA-SSRIPRG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53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Q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NHMANNGENIEYSLNTVNDLDT-SSRIPRG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53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Q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NHMTGTGENIEYSLNGLSDVDS-SSRIPRG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53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Q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SHQANLESPDNSGNNMNSDDSGSSRIPRG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53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Q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NHHQGSLESPDDSANNLNNVNSGSSRTPRG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-------------------------- : 54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N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AGSSFV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RKS--------LFSEIDQAQDYPMDHPQT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</a:t>
            </a:r>
            <a:r>
              <a:rPr lang="en-US" altLang="zh-CN" sz="1050" dirty="0">
                <a:latin typeface="Courier"/>
              </a:rPr>
              <a:t>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DVI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DKKNS-----HKP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DSGF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 : 67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N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A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GGGGEPILRDSNVISSESNPQ--VSRQP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FKSPDIV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GSQNAWTEQAVKRA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DLN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 : 79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QGN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VGA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VG-ETGFPDIHNVANENNPQ--VSRHP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FKSPDIV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GFKASGGEQPFKRA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DLN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 : 78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T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GQS-FFNNLDNSAFDNEIDSK--VSRHP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WKSPDIV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GMKSTNDEQP-KRG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KNDLN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 : 77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R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ST</a:t>
            </a:r>
            <a:r>
              <a:rPr lang="en-US" altLang="zh-CN" sz="1050" dirty="0">
                <a:latin typeface="Courier"/>
              </a:rPr>
              <a:t>--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MGSS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QP-AFNLADNSVFDEETNSM--VSRHP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WKSPDIV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SNFKAINDGQL-KRG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NDLNF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 : 77</a:t>
            </a:r>
            <a:br>
              <a:rPr lang="en-US" altLang="zh-CN" sz="1050" dirty="0">
                <a:latin typeface="Courier"/>
              </a:rPr>
            </a:br>
            <a:r>
              <a:rPr lang="en-US" altLang="zh-CN" sz="1050" dirty="0">
                <a:latin typeface="Courier"/>
              </a:rPr>
              <a:t>--------------------------------------------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T</a:t>
            </a:r>
            <a:r>
              <a:rPr lang="en-US" altLang="zh-CN" sz="1050" dirty="0">
                <a:latin typeface="Courier"/>
              </a:rPr>
              <a:t>--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WKSPDIVIRF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AGFKNLNREQ--KRGR</a:t>
            </a:r>
            <a:r>
              <a:rPr lang="en-US" altLang="zh-CN" sz="1050" b="1" dirty="0">
                <a:effectLst>
                  <a:glow rad="228600">
                    <a:srgbClr val="00FFFF">
                      <a:alpha val="40000"/>
                    </a:srgbClr>
                  </a:glow>
                </a:effectLst>
                <a:latin typeface="Courier"/>
              </a:rPr>
              <a:t>NDLNFIRY</a:t>
            </a:r>
            <a:r>
              <a:rPr lang="en-US" altLang="zh-CN" sz="1050" dirty="0">
                <a:effectLst>
                  <a:glow rad="127000">
                    <a:srgbClr val="FF00FF"/>
                  </a:glow>
                </a:effectLst>
                <a:latin typeface="Courier"/>
              </a:rPr>
              <a:t>G</a:t>
            </a:r>
            <a:r>
              <a:rPr lang="en-US" altLang="zh-CN" sz="1050" dirty="0">
                <a:latin typeface="Courier"/>
              </a:rPr>
              <a:t>R : 38</a:t>
            </a:r>
            <a:endParaRPr lang="zh-CN" altLang="en-US" sz="1050" dirty="0">
              <a:latin typeface="Courier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78002"/>
            <a:ext cx="4279900" cy="375436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3"/>
          <a:srcRect b="20623"/>
          <a:stretch/>
        </p:blipFill>
        <p:spPr>
          <a:xfrm>
            <a:off x="8318500" y="1333501"/>
            <a:ext cx="665056" cy="455612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4"/>
          <a:srcRect b="20331"/>
          <a:stretch/>
        </p:blipFill>
        <p:spPr>
          <a:xfrm>
            <a:off x="4356099" y="1330325"/>
            <a:ext cx="1412875" cy="4953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3165383" y="1097864"/>
            <a:ext cx="3536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chneumonoidea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lcidoidea_FMRFa_1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800265" y="1098593"/>
            <a:ext cx="3536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chneumonoidea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lcidoidea_FMRFa_2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98432" y="90773"/>
            <a:ext cx="5822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v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645318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9821" y="-7437"/>
            <a:ext cx="7487925" cy="6865437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8626662" y="6092047"/>
            <a:ext cx="30716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sulin-like 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ide (ILPs)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98432" y="90773"/>
            <a:ext cx="6527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vi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883003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/>
          <a:srcRect l="19394" r="61673" b="67295"/>
          <a:stretch/>
        </p:blipFill>
        <p:spPr>
          <a:xfrm>
            <a:off x="5953572" y="781822"/>
            <a:ext cx="2160797" cy="498219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01337" y="0"/>
            <a:ext cx="4557883" cy="6858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/>
          <a:srcRect l="18786" r="69956" b="92857"/>
          <a:stretch/>
        </p:blipFill>
        <p:spPr>
          <a:xfrm>
            <a:off x="5953571" y="5735443"/>
            <a:ext cx="1314206" cy="1113032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5"/>
          <a:srcRect l="10283" r="68404" b="95183"/>
          <a:stretch/>
        </p:blipFill>
        <p:spPr>
          <a:xfrm>
            <a:off x="5953571" y="57537"/>
            <a:ext cx="2400746" cy="72428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6"/>
          <a:srcRect t="10283"/>
          <a:stretch/>
        </p:blipFill>
        <p:spPr>
          <a:xfrm>
            <a:off x="8073132" y="2996999"/>
            <a:ext cx="2224810" cy="55184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8314676" y="3548840"/>
            <a:ext cx="19992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menoptera_ITG</a:t>
            </a:r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ike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右大括号 10"/>
          <p:cNvSpPr/>
          <p:nvPr/>
        </p:nvSpPr>
        <p:spPr>
          <a:xfrm>
            <a:off x="7950200" y="781821"/>
            <a:ext cx="241543" cy="495362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98432" y="90773"/>
            <a:ext cx="511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ix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7246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5902" y="330202"/>
            <a:ext cx="5327693" cy="615895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/>
          <a:srcRect l="29361" t="-1" r="45715" b="48947"/>
          <a:stretch/>
        </p:blipFill>
        <p:spPr>
          <a:xfrm>
            <a:off x="6816125" y="330201"/>
            <a:ext cx="2176816" cy="607422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/>
          <a:srcRect l="8241" t="5790" r="3091" b="21159"/>
          <a:stretch/>
        </p:blipFill>
        <p:spPr>
          <a:xfrm>
            <a:off x="9406840" y="2425219"/>
            <a:ext cx="2523281" cy="574748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9275416" y="3198069"/>
            <a:ext cx="27398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ps_AKH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右大括号 1"/>
          <p:cNvSpPr/>
          <p:nvPr/>
        </p:nvSpPr>
        <p:spPr>
          <a:xfrm>
            <a:off x="8877300" y="1461770"/>
            <a:ext cx="285750" cy="281178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>
            <a:off x="109583" y="79621"/>
            <a:ext cx="3257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895518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12881" r="6983" b="54180"/>
          <a:stretch/>
        </p:blipFill>
        <p:spPr>
          <a:xfrm>
            <a:off x="2318365" y="1120140"/>
            <a:ext cx="9793624" cy="490347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108709"/>
            <a:ext cx="2281382" cy="4869181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245596" y="577040"/>
            <a:ext cx="33938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transport 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ides (ITPs)</a:t>
            </a:r>
            <a:endParaRPr lang="en-US" altLang="zh-CN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98432" y="90773"/>
            <a:ext cx="4411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952399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/>
          <a:srcRect l="26470" t="16808" r="2589"/>
          <a:stretch/>
        </p:blipFill>
        <p:spPr>
          <a:xfrm>
            <a:off x="8124500" y="1728438"/>
            <a:ext cx="3429000" cy="718644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7561" y="1170878"/>
            <a:ext cx="7207562" cy="3783330"/>
          </a:xfrm>
          <a:prstGeom prst="rect">
            <a:avLst/>
          </a:prstGeom>
        </p:spPr>
      </p:pic>
      <p:sp>
        <p:nvSpPr>
          <p:cNvPr id="9" name="右大括号 8"/>
          <p:cNvSpPr/>
          <p:nvPr/>
        </p:nvSpPr>
        <p:spPr>
          <a:xfrm>
            <a:off x="7461281" y="1330898"/>
            <a:ext cx="171450" cy="152019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>
            <a:off x="8344569" y="2711515"/>
            <a:ext cx="27815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Kin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98432" y="90773"/>
            <a:ext cx="511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535729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17287" r="67166" b="73213"/>
          <a:stretch/>
        </p:blipFill>
        <p:spPr>
          <a:xfrm>
            <a:off x="5471533" y="613315"/>
            <a:ext cx="2036494" cy="4683513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1543" y="535257"/>
            <a:ext cx="4939991" cy="4802361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7731253" y="3202168"/>
            <a:ext cx="38811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ps_Myosuppress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右大括号 7"/>
          <p:cNvSpPr/>
          <p:nvPr/>
        </p:nvSpPr>
        <p:spPr>
          <a:xfrm>
            <a:off x="7528188" y="1509317"/>
            <a:ext cx="166154" cy="249397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729220" y="2399030"/>
            <a:ext cx="1998223" cy="55245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98432" y="90773"/>
            <a:ext cx="5822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533912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/>
          <a:srcRect l="73243" t="36583" r="2999" b="19825"/>
          <a:stretch/>
        </p:blipFill>
        <p:spPr>
          <a:xfrm>
            <a:off x="9199880" y="5441592"/>
            <a:ext cx="685800" cy="442609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3"/>
          <a:srcRect l="80749" t="3607" r="2654" b="5475"/>
          <a:stretch/>
        </p:blipFill>
        <p:spPr>
          <a:xfrm>
            <a:off x="9205952" y="6416288"/>
            <a:ext cx="709651" cy="430561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4"/>
          <a:srcRect l="66830" t="2984" r="2999" b="3607"/>
          <a:stretch/>
        </p:blipFill>
        <p:spPr>
          <a:xfrm>
            <a:off x="9202571" y="5951130"/>
            <a:ext cx="676198" cy="451569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5"/>
          <a:srcRect l="80990" t="5475" r="2998" b="4852"/>
          <a:stretch/>
        </p:blipFill>
        <p:spPr>
          <a:xfrm>
            <a:off x="9183369" y="4954357"/>
            <a:ext cx="692303" cy="442608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6"/>
          <a:srcRect l="74353" t="5744" r="3059" b="5319"/>
          <a:stretch/>
        </p:blipFill>
        <p:spPr>
          <a:xfrm>
            <a:off x="9194939" y="4458106"/>
            <a:ext cx="667881" cy="43319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7"/>
          <a:srcRect l="80784" t="27143" r="3170" b="5198"/>
          <a:stretch/>
        </p:blipFill>
        <p:spPr>
          <a:xfrm>
            <a:off x="8727440" y="3114040"/>
            <a:ext cx="1135380" cy="441960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8480553" y="1651000"/>
            <a:ext cx="31165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chneumonoidea_Natalis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右大括号 20"/>
          <p:cNvSpPr/>
          <p:nvPr/>
        </p:nvSpPr>
        <p:spPr>
          <a:xfrm>
            <a:off x="8226688" y="312977"/>
            <a:ext cx="218812" cy="2056843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0" y="0"/>
            <a:ext cx="8306725" cy="6858000"/>
          </a:xfrm>
          <a:prstGeom prst="rect">
            <a:avLst/>
          </a:prstGeom>
        </p:spPr>
      </p:pic>
      <p:sp>
        <p:nvSpPr>
          <p:cNvPr id="24" name="右大括号 23"/>
          <p:cNvSpPr/>
          <p:nvPr/>
        </p:nvSpPr>
        <p:spPr>
          <a:xfrm>
            <a:off x="8249548" y="2720897"/>
            <a:ext cx="218812" cy="1561543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9"/>
          <a:srcRect l="83835" t="26596" r="2941" b="4610"/>
          <a:stretch/>
        </p:blipFill>
        <p:spPr>
          <a:xfrm>
            <a:off x="8676640" y="1049019"/>
            <a:ext cx="1226820" cy="457201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98432" y="90773"/>
            <a:ext cx="6527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i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060196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/>
          <a:srcRect l="68494" t="8717" r="3443" b="5969"/>
          <a:stretch/>
        </p:blipFill>
        <p:spPr>
          <a:xfrm>
            <a:off x="8251902" y="2051823"/>
            <a:ext cx="858644" cy="733772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8075123" y="2963474"/>
            <a:ext cx="30513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menoptera_Tachykin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3"/>
          <a:srcRect l="62304" t="4808" r="3091" b="5520"/>
          <a:stretch/>
        </p:blipFill>
        <p:spPr>
          <a:xfrm>
            <a:off x="8320011" y="5837878"/>
            <a:ext cx="879745" cy="27155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4"/>
          <a:srcRect l="52582" t="6098" r="3342" b="6098"/>
          <a:stretch/>
        </p:blipFill>
        <p:spPr>
          <a:xfrm>
            <a:off x="8331160" y="5118406"/>
            <a:ext cx="862398" cy="283724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5"/>
          <a:srcRect l="56370" t="6720" r="3171" b="6098"/>
          <a:stretch/>
        </p:blipFill>
        <p:spPr>
          <a:xfrm>
            <a:off x="8328085" y="5478177"/>
            <a:ext cx="865475" cy="271558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6"/>
          <a:srcRect l="66872" t="5475" r="3342" b="6098"/>
          <a:stretch/>
        </p:blipFill>
        <p:spPr>
          <a:xfrm>
            <a:off x="8329961" y="6173266"/>
            <a:ext cx="880947" cy="279758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7"/>
          <a:srcRect l="56371" t="4852" r="3343" b="5475"/>
          <a:stretch/>
        </p:blipFill>
        <p:spPr>
          <a:xfrm>
            <a:off x="8329961" y="6532349"/>
            <a:ext cx="880947" cy="269894"/>
          </a:xfrm>
          <a:prstGeom prst="rect">
            <a:avLst/>
          </a:prstGeom>
        </p:spPr>
      </p:pic>
      <p:sp>
        <p:nvSpPr>
          <p:cNvPr id="16" name="右大括号 15"/>
          <p:cNvSpPr/>
          <p:nvPr/>
        </p:nvSpPr>
        <p:spPr>
          <a:xfrm>
            <a:off x="7968042" y="230582"/>
            <a:ext cx="138895" cy="4575594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61171" y="0"/>
            <a:ext cx="6343812" cy="685800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98432" y="90773"/>
            <a:ext cx="6399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iv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187067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4753" y="0"/>
            <a:ext cx="8991344" cy="68580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873571" y="89209"/>
            <a:ext cx="15618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ropars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98432" y="90773"/>
            <a:ext cx="5693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v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270467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6380" y="1037062"/>
            <a:ext cx="3702205" cy="457377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471960"/>
            <a:ext cx="3957116" cy="3294743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4"/>
          <a:srcRect l="13957" r="2918" b="75013"/>
          <a:stretch/>
        </p:blipFill>
        <p:spPr>
          <a:xfrm>
            <a:off x="3992137" y="1505414"/>
            <a:ext cx="8110655" cy="3256157"/>
          </a:xfrm>
          <a:prstGeom prst="rect">
            <a:avLst/>
          </a:prstGeom>
        </p:spPr>
      </p:pic>
      <p:sp>
        <p:nvSpPr>
          <p:cNvPr id="14" name="文本框 13"/>
          <p:cNvSpPr txBox="1"/>
          <p:nvPr/>
        </p:nvSpPr>
        <p:spPr>
          <a:xfrm>
            <a:off x="1427356" y="1072286"/>
            <a:ext cx="26564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NPF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98432" y="90773"/>
            <a:ext cx="6399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v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092266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9762" y="4624754"/>
            <a:ext cx="5826369" cy="1019909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6769" y="439616"/>
            <a:ext cx="7068601" cy="41808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910932" y="5002447"/>
            <a:ext cx="29562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NPLP1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98432" y="90773"/>
            <a:ext cx="7104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v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024028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8284" y="9900"/>
            <a:ext cx="5867400" cy="684810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3"/>
          <a:srcRect l="8049" t="11079" r="8450"/>
          <a:stretch/>
        </p:blipFill>
        <p:spPr>
          <a:xfrm>
            <a:off x="7605135" y="3678651"/>
            <a:ext cx="2932770" cy="566386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4"/>
          <a:srcRect l="7360" r="24634"/>
          <a:stretch/>
        </p:blipFill>
        <p:spPr>
          <a:xfrm>
            <a:off x="7582830" y="1637978"/>
            <a:ext cx="3557240" cy="602166"/>
          </a:xfrm>
          <a:prstGeom prst="rect">
            <a:avLst/>
          </a:prstGeom>
        </p:spPr>
      </p:pic>
      <p:sp>
        <p:nvSpPr>
          <p:cNvPr id="14" name="右大括号 13"/>
          <p:cNvSpPr/>
          <p:nvPr/>
        </p:nvSpPr>
        <p:spPr>
          <a:xfrm>
            <a:off x="6634229" y="1559919"/>
            <a:ext cx="636365" cy="4527395"/>
          </a:xfrm>
          <a:prstGeom prst="rightBrace">
            <a:avLst>
              <a:gd name="adj1" fmla="val 8333"/>
              <a:gd name="adj2" fmla="val 49015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7499861" y="3094335"/>
            <a:ext cx="35896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Orcokinin_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右大括号 16"/>
          <p:cNvSpPr/>
          <p:nvPr/>
        </p:nvSpPr>
        <p:spPr>
          <a:xfrm>
            <a:off x="6991815" y="221773"/>
            <a:ext cx="414763" cy="6534615"/>
          </a:xfrm>
          <a:prstGeom prst="rightBrace">
            <a:avLst>
              <a:gd name="adj1" fmla="val 8333"/>
              <a:gd name="adj2" fmla="val 24655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>
            <a:off x="7511012" y="1053663"/>
            <a:ext cx="24995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ects_Orcokinin_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98432" y="90773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vi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570860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12700"/>
            <a:ext cx="7257107" cy="6870700"/>
          </a:xfrm>
          <a:prstGeom prst="rect">
            <a:avLst/>
          </a:prstGeom>
        </p:spPr>
      </p:pic>
      <p:sp>
        <p:nvSpPr>
          <p:cNvPr id="15" name="右大括号 14"/>
          <p:cNvSpPr/>
          <p:nvPr/>
        </p:nvSpPr>
        <p:spPr>
          <a:xfrm>
            <a:off x="7113732" y="256478"/>
            <a:ext cx="270543" cy="28547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30146" y="3633904"/>
            <a:ext cx="2895600" cy="4191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17369" y="4092499"/>
            <a:ext cx="2910468" cy="387968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5"/>
          <a:srcRect t="44084"/>
          <a:stretch/>
        </p:blipFill>
        <p:spPr>
          <a:xfrm>
            <a:off x="7317368" y="4457692"/>
            <a:ext cx="2921620" cy="448845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6"/>
          <a:srcRect t="45329" r="4835"/>
          <a:stretch/>
        </p:blipFill>
        <p:spPr>
          <a:xfrm>
            <a:off x="7295066" y="4906536"/>
            <a:ext cx="3021981" cy="430525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7"/>
          <a:srcRect t="59503" b="-1"/>
          <a:stretch/>
        </p:blipFill>
        <p:spPr>
          <a:xfrm>
            <a:off x="7283915" y="5296831"/>
            <a:ext cx="3211551" cy="479502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8"/>
          <a:srcRect l="7016" t="45952" r="2239" b="-1868"/>
          <a:stretch/>
        </p:blipFill>
        <p:spPr>
          <a:xfrm>
            <a:off x="6826715" y="5876693"/>
            <a:ext cx="3334214" cy="423746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28520" y="6411949"/>
            <a:ext cx="2899318" cy="446049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0"/>
          <a:srcRect l="6615" b="-2314"/>
          <a:stretch/>
        </p:blipFill>
        <p:spPr>
          <a:xfrm>
            <a:off x="7518089" y="1471959"/>
            <a:ext cx="2698596" cy="39029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340108" y="3222703"/>
            <a:ext cx="2865426" cy="404929"/>
          </a:xfrm>
          <a:prstGeom prst="rect">
            <a:avLst/>
          </a:prstGeom>
        </p:spPr>
      </p:pic>
      <p:sp>
        <p:nvSpPr>
          <p:cNvPr id="26" name="右大括号 25"/>
          <p:cNvSpPr/>
          <p:nvPr/>
        </p:nvSpPr>
        <p:spPr>
          <a:xfrm>
            <a:off x="6834951" y="5854389"/>
            <a:ext cx="270543" cy="44604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>
            <a:off x="7399500" y="1043764"/>
            <a:ext cx="37034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Orcokinin_B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98432" y="90773"/>
            <a:ext cx="6399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ix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07283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8078" y="1212742"/>
            <a:ext cx="6720526" cy="497586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/>
          <a:srcRect l="28971" r="45220" b="68098"/>
          <a:stretch/>
        </p:blipFill>
        <p:spPr>
          <a:xfrm>
            <a:off x="7248604" y="1287613"/>
            <a:ext cx="2955064" cy="488678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/>
          <a:srcRect l="8217" t="5338" r="3051" b="20552"/>
          <a:stretch/>
        </p:blipFill>
        <p:spPr>
          <a:xfrm>
            <a:off x="7317096" y="692342"/>
            <a:ext cx="2362162" cy="545444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4293218" y="816801"/>
            <a:ext cx="3012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ps_CRZ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89210" y="89210"/>
            <a:ext cx="3962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52104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26402" r="34906" b="70067"/>
          <a:stretch/>
        </p:blipFill>
        <p:spPr>
          <a:xfrm>
            <a:off x="6758250" y="1190528"/>
            <a:ext cx="4038601" cy="4256088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1015" y="1115122"/>
            <a:ext cx="6167234" cy="44069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4"/>
          <a:srcRect l="7804" t="5987" r="3289" b="20459"/>
          <a:stretch/>
        </p:blipFill>
        <p:spPr>
          <a:xfrm>
            <a:off x="6735336" y="613317"/>
            <a:ext cx="3579541" cy="423747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3853412" y="641067"/>
            <a:ext cx="26564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PDF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98432" y="90773"/>
            <a:ext cx="5693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x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2861457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01698" y="1115122"/>
            <a:ext cx="7896750" cy="506730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519038" y="753832"/>
            <a:ext cx="42326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horacicotropic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ormone (PTTH)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98432" y="90773"/>
            <a:ext cx="6399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x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4008500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199" y="579864"/>
            <a:ext cx="7450162" cy="5107259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/>
          <a:srcRect l="15412"/>
          <a:stretch/>
        </p:blipFill>
        <p:spPr>
          <a:xfrm>
            <a:off x="8408019" y="2598235"/>
            <a:ext cx="3216518" cy="88002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/>
          <a:srcRect l="21253"/>
          <a:stretch/>
        </p:blipFill>
        <p:spPr>
          <a:xfrm>
            <a:off x="8419169" y="4113880"/>
            <a:ext cx="3238821" cy="1137107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8309295" y="2383611"/>
            <a:ext cx="28242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menoptera_RYamide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8191236" y="3874920"/>
            <a:ext cx="315926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RYamide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右大括号 10"/>
          <p:cNvSpPr/>
          <p:nvPr/>
        </p:nvSpPr>
        <p:spPr>
          <a:xfrm>
            <a:off x="7682443" y="2843561"/>
            <a:ext cx="379887" cy="2743199"/>
          </a:xfrm>
          <a:prstGeom prst="rightBrace">
            <a:avLst>
              <a:gd name="adj1" fmla="val 8333"/>
              <a:gd name="adj2" fmla="val 49187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右大括号 12"/>
          <p:cNvSpPr/>
          <p:nvPr/>
        </p:nvSpPr>
        <p:spPr>
          <a:xfrm>
            <a:off x="7794702" y="1806498"/>
            <a:ext cx="512956" cy="3791414"/>
          </a:xfrm>
          <a:prstGeom prst="rightBrace">
            <a:avLst>
              <a:gd name="adj1" fmla="val 8333"/>
              <a:gd name="adj2" fmla="val 24655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98432" y="90773"/>
            <a:ext cx="7104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x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9031584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26069" t="31499"/>
          <a:stretch/>
        </p:blipFill>
        <p:spPr>
          <a:xfrm>
            <a:off x="8129239" y="1003610"/>
            <a:ext cx="2408663" cy="52779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8674" y="1538868"/>
            <a:ext cx="6299200" cy="4224724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4"/>
          <a:srcRect l="19779" r="59091" b="80066"/>
          <a:stretch/>
        </p:blipFill>
        <p:spPr>
          <a:xfrm>
            <a:off x="7534508" y="1574054"/>
            <a:ext cx="3309427" cy="4167237"/>
          </a:xfrm>
          <a:prstGeom prst="rect">
            <a:avLst/>
          </a:prstGeom>
        </p:spPr>
      </p:pic>
      <p:sp>
        <p:nvSpPr>
          <p:cNvPr id="7" name="右大括号 6"/>
          <p:cNvSpPr/>
          <p:nvPr/>
        </p:nvSpPr>
        <p:spPr>
          <a:xfrm>
            <a:off x="10916298" y="1616926"/>
            <a:ext cx="270543" cy="281010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4540186" y="1056615"/>
            <a:ext cx="28889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menoptera_SIFamide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98432" y="90773"/>
            <a:ext cx="7809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xi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3297046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/>
          <a:srcRect l="31401"/>
          <a:stretch/>
        </p:blipFill>
        <p:spPr>
          <a:xfrm>
            <a:off x="4229100" y="1436649"/>
            <a:ext cx="1795349" cy="457267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815059" y="1482805"/>
            <a:ext cx="32944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sulfakin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/>
          <a:srcRect l="20364" r="10771" b="66467"/>
          <a:stretch/>
        </p:blipFill>
        <p:spPr>
          <a:xfrm>
            <a:off x="3717620" y="1911576"/>
            <a:ext cx="8064805" cy="2155599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852" y="1857377"/>
            <a:ext cx="3400424" cy="2149458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98432" y="90773"/>
            <a:ext cx="7681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xiv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3418722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/>
          <a:srcRect t="30851" b="21192"/>
          <a:stretch/>
        </p:blipFill>
        <p:spPr>
          <a:xfrm>
            <a:off x="5675971" y="1053093"/>
            <a:ext cx="6003305" cy="433388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2675685" y="1092745"/>
            <a:ext cx="29051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ps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_Triss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578903"/>
            <a:ext cx="5968003" cy="4052462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/>
          <a:srcRect l="23380" r="27644" b="73619"/>
          <a:stretch/>
        </p:blipFill>
        <p:spPr>
          <a:xfrm>
            <a:off x="5974266" y="1612938"/>
            <a:ext cx="5927802" cy="4029579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98432" y="90773"/>
            <a:ext cx="697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xxv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12749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15200" y="3175000"/>
            <a:ext cx="4495800" cy="819150"/>
          </a:xfrm>
          <a:prstGeom prst="rect">
            <a:avLst/>
          </a:prstGeom>
        </p:spPr>
      </p:pic>
      <p:sp>
        <p:nvSpPr>
          <p:cNvPr id="19" name="文本框 18"/>
          <p:cNvSpPr txBox="1"/>
          <p:nvPr/>
        </p:nvSpPr>
        <p:spPr>
          <a:xfrm>
            <a:off x="7474356" y="4275538"/>
            <a:ext cx="39454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AST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11734"/>
            <a:ext cx="7247101" cy="6869734"/>
          </a:xfrm>
          <a:prstGeom prst="rect">
            <a:avLst/>
          </a:prstGeom>
        </p:spPr>
      </p:pic>
      <p:sp>
        <p:nvSpPr>
          <p:cNvPr id="20" name="右大括号 19"/>
          <p:cNvSpPr/>
          <p:nvPr/>
        </p:nvSpPr>
        <p:spPr>
          <a:xfrm>
            <a:off x="7175500" y="1804670"/>
            <a:ext cx="317500" cy="411353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文本框 5"/>
          <p:cNvSpPr txBox="1"/>
          <p:nvPr/>
        </p:nvSpPr>
        <p:spPr>
          <a:xfrm>
            <a:off x="98432" y="90773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v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7961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/>
          <a:srcRect l="28369" r="33325" b="67905"/>
          <a:stretch/>
        </p:blipFill>
        <p:spPr>
          <a:xfrm>
            <a:off x="6927138" y="1192683"/>
            <a:ext cx="4269617" cy="4873308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153" y="1099057"/>
            <a:ext cx="6586651" cy="496693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4"/>
          <a:srcRect l="7687" t="27725"/>
          <a:stretch/>
        </p:blipFill>
        <p:spPr>
          <a:xfrm>
            <a:off x="7973123" y="570570"/>
            <a:ext cx="2832410" cy="592609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4750418" y="697262"/>
            <a:ext cx="26135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ps_AT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8432" y="90773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48199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/>
          <a:srcRect l="8235" t="1" b="20715"/>
          <a:stretch/>
        </p:blipFill>
        <p:spPr>
          <a:xfrm>
            <a:off x="7150101" y="5638799"/>
            <a:ext cx="2171699" cy="49524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273300" y="5737825"/>
            <a:ext cx="56479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 &amp; other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sects_AVLP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8700" y="297108"/>
            <a:ext cx="7432513" cy="497849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98432" y="90773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33698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0061" y="0"/>
            <a:ext cx="5316663" cy="6879176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9239980" y="6092047"/>
            <a:ext cx="1850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rsicon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altLang="zh-CN" sz="2000" b="1" dirty="0" smtClean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α</a:t>
            </a:r>
            <a:r>
              <a:rPr lang="en-US" altLang="zh-CN" sz="2000" b="1" dirty="0" smtClean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 &amp; </a:t>
            </a:r>
            <a:r>
              <a:rPr lang="el-GR" altLang="zh-CN" sz="2000" b="1" dirty="0" smtClean="0">
                <a:latin typeface="Times New Roman" panose="02020603050405020304" pitchFamily="18" charset="0"/>
                <a:ea typeface="仿宋" panose="02010609060101010101" pitchFamily="49" charset="-122"/>
                <a:cs typeface="Times New Roman" panose="02020603050405020304" pitchFamily="18" charset="0"/>
              </a:rPr>
              <a:t>β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98432" y="90773"/>
            <a:ext cx="4539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21883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/>
          <a:srcRect l="7475" t="35989" r="2826"/>
          <a:stretch/>
        </p:blipFill>
        <p:spPr>
          <a:xfrm>
            <a:off x="5524809" y="508000"/>
            <a:ext cx="6172201" cy="668258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3"/>
          <a:srcRect t="15097" r="3333"/>
          <a:stretch/>
        </p:blipFill>
        <p:spPr>
          <a:xfrm>
            <a:off x="5118410" y="1803401"/>
            <a:ext cx="6629400" cy="68580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5379026" y="203200"/>
            <a:ext cx="4679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trypto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K: </a:t>
            </a:r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FGPRL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401971" y="1520298"/>
            <a:ext cx="330411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PK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L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698430" y="5000711"/>
            <a:ext cx="36653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PVK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PRV/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110" y="0"/>
            <a:ext cx="4813300" cy="686779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5"/>
          <a:srcRect l="28824" t="26648"/>
          <a:stretch/>
        </p:blipFill>
        <p:spPr>
          <a:xfrm>
            <a:off x="10503210" y="4876799"/>
            <a:ext cx="1193800" cy="635001"/>
          </a:xfrm>
          <a:prstGeom prst="rect">
            <a:avLst/>
          </a:prstGeom>
        </p:spPr>
      </p:pic>
      <p:sp>
        <p:nvSpPr>
          <p:cNvPr id="9" name="右大括号 8"/>
          <p:cNvSpPr/>
          <p:nvPr/>
        </p:nvSpPr>
        <p:spPr>
          <a:xfrm>
            <a:off x="4889810" y="163460"/>
            <a:ext cx="317500" cy="224663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右大括号 12"/>
          <p:cNvSpPr/>
          <p:nvPr/>
        </p:nvSpPr>
        <p:spPr>
          <a:xfrm>
            <a:off x="5283510" y="4657990"/>
            <a:ext cx="317500" cy="113030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98432" y="90773"/>
            <a:ext cx="5245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ii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23497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/>
          <a:srcRect l="7253" t="41086" r="3728" b="709"/>
          <a:stretch/>
        </p:blipFill>
        <p:spPr>
          <a:xfrm>
            <a:off x="7683500" y="4775200"/>
            <a:ext cx="3873500" cy="502976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3"/>
          <a:srcRect l="22546" r="29776" b="77797"/>
          <a:stretch/>
        </p:blipFill>
        <p:spPr>
          <a:xfrm>
            <a:off x="5576650" y="620598"/>
            <a:ext cx="6615350" cy="3887902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778773"/>
            <a:ext cx="5340412" cy="3628127"/>
          </a:xfrm>
          <a:prstGeom prst="rect">
            <a:avLst/>
          </a:prstGeom>
        </p:spPr>
      </p:pic>
      <p:cxnSp>
        <p:nvCxnSpPr>
          <p:cNvPr id="15" name="直接连接符 14"/>
          <p:cNvCxnSpPr/>
          <p:nvPr/>
        </p:nvCxnSpPr>
        <p:spPr>
          <a:xfrm flipV="1">
            <a:off x="5281612" y="781050"/>
            <a:ext cx="252413" cy="182564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5286375" y="1003300"/>
            <a:ext cx="25241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3412120" y="4876621"/>
            <a:ext cx="366536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asitoid 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ps_ETH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PRV/</a:t>
            </a:r>
            <a:r>
              <a:rPr lang="en-US" altLang="zh-CN" sz="2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98432" y="90773"/>
            <a:ext cx="38343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x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70265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54</TotalTime>
  <Words>147</Words>
  <Application>Microsoft Office PowerPoint</Application>
  <PresentationFormat>宽屏</PresentationFormat>
  <Paragraphs>79</Paragraphs>
  <Slides>35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5</vt:i4>
      </vt:variant>
    </vt:vector>
  </HeadingPairs>
  <TitlesOfParts>
    <vt:vector size="43" baseType="lpstr">
      <vt:lpstr>Courier</vt:lpstr>
      <vt:lpstr>仿宋</vt:lpstr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ina</dc:creator>
  <cp:lastModifiedBy>China</cp:lastModifiedBy>
  <cp:revision>298</cp:revision>
  <dcterms:created xsi:type="dcterms:W3CDTF">2016-12-03T09:23:27Z</dcterms:created>
  <dcterms:modified xsi:type="dcterms:W3CDTF">2018-02-17T04:28:25Z</dcterms:modified>
</cp:coreProperties>
</file>